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315200" cy="100584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>
        <p:scale>
          <a:sx n="100" d="100"/>
          <a:sy n="100" d="100"/>
        </p:scale>
        <p:origin x="114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517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389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954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03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046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126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136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595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376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833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115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EC22F-423C-494E-9012-325DC687202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D5BBC0-54E7-45A1-A09D-3B6E436D5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593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21744" y="4927926"/>
            <a:ext cx="617006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tracellular growth of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conorii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HMECs and AAE2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ells,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HMECs infected with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conorii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ither maintained at 37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 or 34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, and AAE2 cells infected with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conorii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aintained at 34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. Total DNA was extracted a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4h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ost-infection an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ickettsial number was enumerated by quantitative PCR using citrate synthase gene specific primers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Data from three independent biological replicates is presented as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4622" y="623397"/>
            <a:ext cx="3817620" cy="3998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34503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4</TotalTime>
  <Words>78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TMB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rra, Hema P.</dc:creator>
  <cp:lastModifiedBy>Narra, Hema P.</cp:lastModifiedBy>
  <cp:revision>6</cp:revision>
  <cp:lastPrinted>2020-08-12T15:13:52Z</cp:lastPrinted>
  <dcterms:created xsi:type="dcterms:W3CDTF">2020-08-12T15:01:53Z</dcterms:created>
  <dcterms:modified xsi:type="dcterms:W3CDTF">2020-08-24T17:01:15Z</dcterms:modified>
</cp:coreProperties>
</file>